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FBC6B6-E590-4B1E-9B49-D88AA905A51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8E4CA9-432C-4ECE-84E1-BF930F053E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F375C6-7066-49B1-8E7C-71C78CFCC22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A93F36-9C08-4B96-8386-AF9D3AF96C3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B6E6E8-4A6F-4B72-9FFB-067E4498B4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8CD904-2474-4B7B-9961-0FCF1C73609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B4A690-B742-484F-AA90-E59A3FE92D6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E91C66-212B-4537-AE3E-25A0FC4789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CC660F-5525-434E-B5D5-42C306F5182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AED572-8C61-48DA-905B-B3DBDF5746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9DA3D0-0048-48D2-9A52-837905C3D2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CCE408-19C7-457B-BCAF-15B38EB23F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BD2898F-C39A-4545-9CAF-34485A5C7CEF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asellaDiTesto 3"/>
          <p:cNvSpPr/>
          <p:nvPr/>
        </p:nvSpPr>
        <p:spPr>
          <a:xfrm>
            <a:off x="2565360" y="169920"/>
            <a:ext cx="64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0 G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CasellaDiTesto 4"/>
          <p:cNvSpPr/>
          <p:nvPr/>
        </p:nvSpPr>
        <p:spPr>
          <a:xfrm>
            <a:off x="5013360" y="169920"/>
            <a:ext cx="64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2 G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CasellaDiTesto 5"/>
          <p:cNvSpPr/>
          <p:nvPr/>
        </p:nvSpPr>
        <p:spPr>
          <a:xfrm>
            <a:off x="966960" y="716040"/>
            <a:ext cx="517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Calibri"/>
              </a:rPr>
              <a:t>CT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CasellaDiTesto 6"/>
          <p:cNvSpPr/>
          <p:nvPr/>
        </p:nvSpPr>
        <p:spPr>
          <a:xfrm>
            <a:off x="401760" y="1249200"/>
            <a:ext cx="1082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Calibri"/>
              </a:rPr>
              <a:t>VPA 2,5m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CasellaDiTesto 7"/>
          <p:cNvSpPr/>
          <p:nvPr/>
        </p:nvSpPr>
        <p:spPr>
          <a:xfrm>
            <a:off x="189000" y="2041560"/>
            <a:ext cx="12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Calibri"/>
              </a:rPr>
              <a:t>5’-DFUR 5µ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CasellaDiTesto 8"/>
          <p:cNvSpPr/>
          <p:nvPr/>
        </p:nvSpPr>
        <p:spPr>
          <a:xfrm>
            <a:off x="189000" y="2546280"/>
            <a:ext cx="12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Calibri"/>
              </a:rPr>
              <a:t>5’-DFUR 10µ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CasellaDiTesto 9"/>
          <p:cNvSpPr/>
          <p:nvPr/>
        </p:nvSpPr>
        <p:spPr>
          <a:xfrm>
            <a:off x="-239760" y="3338640"/>
            <a:ext cx="172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Calibri"/>
              </a:rPr>
              <a:t>VPA + 5’-DFUR 5µ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CasellaDiTesto 10"/>
          <p:cNvSpPr/>
          <p:nvPr/>
        </p:nvSpPr>
        <p:spPr>
          <a:xfrm>
            <a:off x="-239760" y="3986280"/>
            <a:ext cx="172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Calibri"/>
              </a:rPr>
              <a:t>VPA + 5’-DFUR 10µ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CasellaDiTesto 11"/>
          <p:cNvSpPr/>
          <p:nvPr/>
        </p:nvSpPr>
        <p:spPr>
          <a:xfrm>
            <a:off x="189000" y="108000"/>
            <a:ext cx="73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HT2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Picture 2" descr=""/>
          <p:cNvPicPr/>
          <p:nvPr/>
        </p:nvPicPr>
        <p:blipFill>
          <a:blip r:embed="rId1"/>
          <a:stretch/>
        </p:blipFill>
        <p:spPr>
          <a:xfrm>
            <a:off x="1527120" y="446040"/>
            <a:ext cx="5070600" cy="3989520"/>
          </a:xfrm>
          <a:prstGeom prst="rect">
            <a:avLst/>
          </a:prstGeom>
          <a:ln w="0">
            <a:noFill/>
          </a:ln>
        </p:spPr>
      </p:pic>
      <p:sp>
        <p:nvSpPr>
          <p:cNvPr id="51" name="CasellaDiTesto 20"/>
          <p:cNvSpPr/>
          <p:nvPr/>
        </p:nvSpPr>
        <p:spPr>
          <a:xfrm>
            <a:off x="5318280" y="8775720"/>
            <a:ext cx="185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Supp Figure S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CasellaDiTesto 5"/>
          <p:cNvSpPr/>
          <p:nvPr/>
        </p:nvSpPr>
        <p:spPr>
          <a:xfrm>
            <a:off x="979560" y="4930920"/>
            <a:ext cx="504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CT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CasellaDiTesto 6"/>
          <p:cNvSpPr/>
          <p:nvPr/>
        </p:nvSpPr>
        <p:spPr>
          <a:xfrm>
            <a:off x="428760" y="5435640"/>
            <a:ext cx="1055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Calibri"/>
              </a:rPr>
              <a:t>VPA 1m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CasellaDiTesto 7"/>
          <p:cNvSpPr/>
          <p:nvPr/>
        </p:nvSpPr>
        <p:spPr>
          <a:xfrm>
            <a:off x="222120" y="6154560"/>
            <a:ext cx="126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Calibri"/>
              </a:rPr>
              <a:t>5’-DFUR 20µ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CasellaDiTesto 8"/>
          <p:cNvSpPr/>
          <p:nvPr/>
        </p:nvSpPr>
        <p:spPr>
          <a:xfrm>
            <a:off x="222120" y="6802560"/>
            <a:ext cx="126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Calibri"/>
              </a:rPr>
              <a:t>5’-DFUR 30µ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CasellaDiTesto 9"/>
          <p:cNvSpPr/>
          <p:nvPr/>
        </p:nvSpPr>
        <p:spPr>
          <a:xfrm>
            <a:off x="-196920" y="7523280"/>
            <a:ext cx="1681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Calibri"/>
              </a:rPr>
              <a:t>VPA + 5’-DFUR 20µ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CasellaDiTesto 10"/>
          <p:cNvSpPr/>
          <p:nvPr/>
        </p:nvSpPr>
        <p:spPr>
          <a:xfrm>
            <a:off x="-196920" y="8099280"/>
            <a:ext cx="1681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Calibri"/>
              </a:rPr>
              <a:t>VPA + 5’-DFUR 30µ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CasellaDiTesto 11"/>
          <p:cNvSpPr/>
          <p:nvPr/>
        </p:nvSpPr>
        <p:spPr>
          <a:xfrm>
            <a:off x="189000" y="4714920"/>
            <a:ext cx="100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W62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9" name="Picture 2" descr=""/>
          <p:cNvPicPr/>
          <p:nvPr/>
        </p:nvPicPr>
        <p:blipFill>
          <a:blip r:embed="rId2"/>
          <a:stretch/>
        </p:blipFill>
        <p:spPr>
          <a:xfrm>
            <a:off x="1527120" y="4633920"/>
            <a:ext cx="5068800" cy="3989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8-02T15:39:30Z</dcterms:created>
  <dc:creator>Alfredo Budillon</dc:creator>
  <dc:description/>
  <dc:language>en-US</dc:language>
  <cp:lastModifiedBy>Alfredo Budillon</cp:lastModifiedBy>
  <dcterms:modified xsi:type="dcterms:W3CDTF">2017-08-02T15:42:55Z</dcterms:modified>
  <cp:revision>5</cp:revision>
  <dc:subject/>
  <dc:title>Presentazione di PowerPoint</dc:title>
</cp:coreProperties>
</file>